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172" autoAdjust="0"/>
    <p:restoredTop sz="94660"/>
  </p:normalViewPr>
  <p:slideViewPr>
    <p:cSldViewPr snapToGrid="0">
      <p:cViewPr>
        <p:scale>
          <a:sx n="66" d="100"/>
          <a:sy n="66" d="100"/>
        </p:scale>
        <p:origin x="304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27113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73202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13778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63992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8451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38348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25476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80611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52902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83793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89139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837F2-2D71-4889-ABBE-8734914D4AD4}" type="datetimeFigureOut">
              <a:rPr lang="zh-TW" altLang="en-US" smtClean="0"/>
              <a:t>2021/1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DE6E5-2D86-4054-809A-C967143B573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60741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0519018"/>
              </p:ext>
            </p:extLst>
          </p:nvPr>
        </p:nvGraphicFramePr>
        <p:xfrm>
          <a:off x="2405525" y="2053926"/>
          <a:ext cx="7404099" cy="2297430"/>
        </p:xfrm>
        <a:graphic>
          <a:graphicData uri="http://schemas.openxmlformats.org/drawingml/2006/table">
            <a:tbl>
              <a:tblPr/>
              <a:tblGrid>
                <a:gridCol w="1094436">
                  <a:extLst>
                    <a:ext uri="{9D8B030D-6E8A-4147-A177-3AD203B41FA5}">
                      <a16:colId xmlns:a16="http://schemas.microsoft.com/office/drawing/2014/main" val="2091206699"/>
                    </a:ext>
                  </a:extLst>
                </a:gridCol>
                <a:gridCol w="799414">
                  <a:extLst>
                    <a:ext uri="{9D8B030D-6E8A-4147-A177-3AD203B41FA5}">
                      <a16:colId xmlns:a16="http://schemas.microsoft.com/office/drawing/2014/main" val="303300512"/>
                    </a:ext>
                  </a:extLst>
                </a:gridCol>
                <a:gridCol w="2921669">
                  <a:extLst>
                    <a:ext uri="{9D8B030D-6E8A-4147-A177-3AD203B41FA5}">
                      <a16:colId xmlns:a16="http://schemas.microsoft.com/office/drawing/2014/main" val="1567301135"/>
                    </a:ext>
                  </a:extLst>
                </a:gridCol>
                <a:gridCol w="2588580">
                  <a:extLst>
                    <a:ext uri="{9D8B030D-6E8A-4147-A177-3AD203B41FA5}">
                      <a16:colId xmlns:a16="http://schemas.microsoft.com/office/drawing/2014/main" val="1866805169"/>
                    </a:ext>
                  </a:extLst>
                </a:gridCol>
              </a:tblGrid>
              <a:tr h="194310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Supplementary Table </a:t>
                      </a: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1.  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Primer sequences used for qPCR in this study</a:t>
                      </a:r>
                    </a:p>
                  </a:txBody>
                  <a:tcPr marL="3810" marR="3810" marT="381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8468493"/>
                  </a:ext>
                </a:extLst>
              </a:tr>
              <a:tr h="19431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Primer Name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Species 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Forword primer sequence (5'-3') 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Reverse primer sequence (5'-3')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46623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IL-6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Mouse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CCAGTTGCCTTCTTGGGAC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TGTAATTAAGCCTCCGACTT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26841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IL-17A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Mouse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CTCCAGAAGGCCCTCA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TTTCCCTCCGCATTGAC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54706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IL-23p19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Mouse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CGTATCCAGTGTGAAGAT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CTTTGAAGATGTCAGAGTC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25191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IL-24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Mouse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GAACCAGCCACCTTCACAC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CAAATCGGAACTCTTGACC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23064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XCL2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Mouse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CTCTCAAGGGCGGTCAAAA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GGCACATCAGGTACGATCC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45499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NF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Mouse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CTCACACTCAGATCATCTTC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CTACGACGTGGGCTACA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57544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F4/80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Mouse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TTCCTCGCCTGCTTCTTC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CCGTCTCTGTATTCAACC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04784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APDH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Mouse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GCTTGTCATCAACGGGAA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TTGATGTTAGTGGGGTCTC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850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Filaggrin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Mouse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GTTTCCAAACACATGGATCAAA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TTTGAATCTTGTTGGTGTCTGTG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1477226"/>
                  </a:ext>
                </a:extLst>
              </a:tr>
              <a:tr h="19431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Involucrin</a:t>
                      </a:r>
                    </a:p>
                  </a:txBody>
                  <a:tcPr marL="3810" marR="3810" marT="381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Mouse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AAACTTGGTGAGCCAGAATTACA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</a:rPr>
                        <a:t>CCTTTCCAGTTGTTTACCCTTCT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94991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53081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5</TotalTime>
  <Words>71</Words>
  <Application>Microsoft Office PowerPoint</Application>
  <PresentationFormat>寬螢幕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士億 莊</dc:creator>
  <cp:lastModifiedBy>莊士億</cp:lastModifiedBy>
  <cp:revision>30</cp:revision>
  <dcterms:created xsi:type="dcterms:W3CDTF">2020-02-11T03:17:50Z</dcterms:created>
  <dcterms:modified xsi:type="dcterms:W3CDTF">2021-01-12T02:30:54Z</dcterms:modified>
</cp:coreProperties>
</file>